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1" r:id="rId2"/>
    <p:sldId id="262" r:id="rId3"/>
    <p:sldId id="256" r:id="rId4"/>
    <p:sldId id="257" r:id="rId5"/>
    <p:sldId id="258" r:id="rId6"/>
    <p:sldId id="259" r:id="rId7"/>
    <p:sldId id="260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2475E19-F3E0-6932-2004-581925918E5D}" v="9" dt="2024-03-25T13:17:47.368"/>
    <p1510:client id="{32E9D7E3-8CFD-75CB-018A-55380A7264B8}" v="637" dt="2024-03-26T14:59:44.932"/>
    <p1510:client id="{C0148E8F-5CF9-999B-CAD0-99853277057E}" v="127" dt="2024-03-27T09:04:53.81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slideViewPr>
    <p:cSldViewPr snapToGrid="0">
      <p:cViewPr>
        <p:scale>
          <a:sx n="1" d="2"/>
          <a:sy n="1" d="2"/>
        </p:scale>
        <p:origin x="0" y="0"/>
      </p:cViewPr>
      <p:guideLst/>
    </p:cSldViewPr>
  </p:slide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clId="Web-{C0148E8F-5CF9-999B-CAD0-99853277057E}"/>
    <pc:docChg chg="modSld">
      <pc:chgData name="" userId="" providerId="" clId="Web-{C0148E8F-5CF9-999B-CAD0-99853277057E}" dt="2024-03-27T08:16:35.169" v="0"/>
      <pc:docMkLst>
        <pc:docMk/>
      </pc:docMkLst>
      <pc:sldChg chg="delSp">
        <pc:chgData name="" userId="" providerId="" clId="Web-{C0148E8F-5CF9-999B-CAD0-99853277057E}" dt="2024-03-27T08:16:35.169" v="0"/>
        <pc:sldMkLst>
          <pc:docMk/>
          <pc:sldMk cId="2445588320" sldId="257"/>
        </pc:sldMkLst>
        <pc:picChg chg="del">
          <ac:chgData name="" userId="" providerId="" clId="Web-{C0148E8F-5CF9-999B-CAD0-99853277057E}" dt="2024-03-27T08:16:35.169" v="0"/>
          <ac:picMkLst>
            <pc:docMk/>
            <pc:sldMk cId="2445588320" sldId="257"/>
            <ac:picMk id="3" creationId="{A1F3F3EB-45C4-CC6E-31B4-1F3F87ABD4BC}"/>
          </ac:picMkLst>
        </pc:picChg>
      </pc:sldChg>
    </pc:docChg>
  </pc:docChgLst>
  <pc:docChgLst>
    <pc:chgData name="Serena Mucciolo" userId="ec261867-03e3-4d89-ac40-a7f885ff8342" providerId="ADAL" clId="{5035C7B7-27EB-4AAC-998A-0D88C12D02AD}"/>
    <pc:docChg chg="modSld">
      <pc:chgData name="Serena Mucciolo" userId="ec261867-03e3-4d89-ac40-a7f885ff8342" providerId="ADAL" clId="{5035C7B7-27EB-4AAC-998A-0D88C12D02AD}" dt="2024-03-05T10:33:23.877" v="12" actId="114"/>
      <pc:docMkLst>
        <pc:docMk/>
      </pc:docMkLst>
      <pc:sldChg chg="modSp mod">
        <pc:chgData name="Serena Mucciolo" userId="ec261867-03e3-4d89-ac40-a7f885ff8342" providerId="ADAL" clId="{5035C7B7-27EB-4AAC-998A-0D88C12D02AD}" dt="2024-03-05T10:32:43.886" v="11" actId="20577"/>
        <pc:sldMkLst>
          <pc:docMk/>
          <pc:sldMk cId="2445588320" sldId="257"/>
        </pc:sldMkLst>
        <pc:spChg chg="mod">
          <ac:chgData name="Serena Mucciolo" userId="ec261867-03e3-4d89-ac40-a7f885ff8342" providerId="ADAL" clId="{5035C7B7-27EB-4AAC-998A-0D88C12D02AD}" dt="2024-03-05T10:32:43.886" v="11" actId="20577"/>
          <ac:spMkLst>
            <pc:docMk/>
            <pc:sldMk cId="2445588320" sldId="257"/>
            <ac:spMk id="5" creationId="{5179C87C-817F-FC72-C2C6-F28A23EA4311}"/>
          </ac:spMkLst>
        </pc:spChg>
      </pc:sldChg>
      <pc:sldChg chg="modSp mod">
        <pc:chgData name="Serena Mucciolo" userId="ec261867-03e3-4d89-ac40-a7f885ff8342" providerId="ADAL" clId="{5035C7B7-27EB-4AAC-998A-0D88C12D02AD}" dt="2024-03-05T10:33:23.877" v="12" actId="114"/>
        <pc:sldMkLst>
          <pc:docMk/>
          <pc:sldMk cId="3414299677" sldId="261"/>
        </pc:sldMkLst>
        <pc:spChg chg="mod">
          <ac:chgData name="Serena Mucciolo" userId="ec261867-03e3-4d89-ac40-a7f885ff8342" providerId="ADAL" clId="{5035C7B7-27EB-4AAC-998A-0D88C12D02AD}" dt="2024-03-05T10:33:23.877" v="12" actId="114"/>
          <ac:spMkLst>
            <pc:docMk/>
            <pc:sldMk cId="3414299677" sldId="261"/>
            <ac:spMk id="10" creationId="{E00E3E5E-C25E-6F7D-3DC3-1B29F849F32C}"/>
          </ac:spMkLst>
        </pc:spChg>
      </pc:sldChg>
    </pc:docChg>
  </pc:docChgLst>
  <pc:docChgLst>
    <pc:chgData name="Serena Mucciolo" userId="S::serena.mucciolo@biol.uni.lodz.pl::ec261867-03e3-4d89-ac40-a7f885ff8342" providerId="AD" clId="Web-{12475E19-F3E0-6932-2004-581925918E5D}"/>
    <pc:docChg chg="modSld">
      <pc:chgData name="Serena Mucciolo" userId="S::serena.mucciolo@biol.uni.lodz.pl::ec261867-03e3-4d89-ac40-a7f885ff8342" providerId="AD" clId="Web-{12475E19-F3E0-6932-2004-581925918E5D}" dt="2024-03-25T13:17:47.368" v="6"/>
      <pc:docMkLst>
        <pc:docMk/>
      </pc:docMkLst>
      <pc:sldChg chg="modSp">
        <pc:chgData name="Serena Mucciolo" userId="S::serena.mucciolo@biol.uni.lodz.pl::ec261867-03e3-4d89-ac40-a7f885ff8342" providerId="AD" clId="Web-{12475E19-F3E0-6932-2004-581925918E5D}" dt="2024-03-25T13:17:47.368" v="6"/>
        <pc:sldMkLst>
          <pc:docMk/>
          <pc:sldMk cId="2445588320" sldId="257"/>
        </pc:sldMkLst>
        <pc:spChg chg="mod">
          <ac:chgData name="Serena Mucciolo" userId="S::serena.mucciolo@biol.uni.lodz.pl::ec261867-03e3-4d89-ac40-a7f885ff8342" providerId="AD" clId="Web-{12475E19-F3E0-6932-2004-581925918E5D}" dt="2024-03-25T13:17:47.368" v="6"/>
          <ac:spMkLst>
            <pc:docMk/>
            <pc:sldMk cId="2445588320" sldId="257"/>
            <ac:spMk id="5" creationId="{5179C87C-817F-FC72-C2C6-F28A23EA4311}"/>
          </ac:spMkLst>
        </pc:spChg>
      </pc:sldChg>
      <pc:sldChg chg="modSp">
        <pc:chgData name="Serena Mucciolo" userId="S::serena.mucciolo@biol.uni.lodz.pl::ec261867-03e3-4d89-ac40-a7f885ff8342" providerId="AD" clId="Web-{12475E19-F3E0-6932-2004-581925918E5D}" dt="2024-03-25T13:01:33.035" v="3"/>
        <pc:sldMkLst>
          <pc:docMk/>
          <pc:sldMk cId="1199539339" sldId="258"/>
        </pc:sldMkLst>
        <pc:spChg chg="mod">
          <ac:chgData name="Serena Mucciolo" userId="S::serena.mucciolo@biol.uni.lodz.pl::ec261867-03e3-4d89-ac40-a7f885ff8342" providerId="AD" clId="Web-{12475E19-F3E0-6932-2004-581925918E5D}" dt="2024-03-25T13:01:33.035" v="3"/>
          <ac:spMkLst>
            <pc:docMk/>
            <pc:sldMk cId="1199539339" sldId="258"/>
            <ac:spMk id="5" creationId="{5179C87C-817F-FC72-C2C6-F28A23EA4311}"/>
          </ac:spMkLst>
        </pc:spChg>
      </pc:sldChg>
      <pc:sldChg chg="modSp">
        <pc:chgData name="Serena Mucciolo" userId="S::serena.mucciolo@biol.uni.lodz.pl::ec261867-03e3-4d89-ac40-a7f885ff8342" providerId="AD" clId="Web-{12475E19-F3E0-6932-2004-581925918E5D}" dt="2024-03-25T13:01:37.175" v="4"/>
        <pc:sldMkLst>
          <pc:docMk/>
          <pc:sldMk cId="127903412" sldId="259"/>
        </pc:sldMkLst>
        <pc:spChg chg="mod">
          <ac:chgData name="Serena Mucciolo" userId="S::serena.mucciolo@biol.uni.lodz.pl::ec261867-03e3-4d89-ac40-a7f885ff8342" providerId="AD" clId="Web-{12475E19-F3E0-6932-2004-581925918E5D}" dt="2024-03-25T13:01:37.175" v="4"/>
          <ac:spMkLst>
            <pc:docMk/>
            <pc:sldMk cId="127903412" sldId="259"/>
            <ac:spMk id="5" creationId="{5179C87C-817F-FC72-C2C6-F28A23EA4311}"/>
          </ac:spMkLst>
        </pc:spChg>
      </pc:sldChg>
      <pc:sldChg chg="modSp">
        <pc:chgData name="Serena Mucciolo" userId="S::serena.mucciolo@biol.uni.lodz.pl::ec261867-03e3-4d89-ac40-a7f885ff8342" providerId="AD" clId="Web-{12475E19-F3E0-6932-2004-581925918E5D}" dt="2024-03-25T13:01:42.097" v="5"/>
        <pc:sldMkLst>
          <pc:docMk/>
          <pc:sldMk cId="2583475902" sldId="260"/>
        </pc:sldMkLst>
        <pc:spChg chg="mod">
          <ac:chgData name="Serena Mucciolo" userId="S::serena.mucciolo@biol.uni.lodz.pl::ec261867-03e3-4d89-ac40-a7f885ff8342" providerId="AD" clId="Web-{12475E19-F3E0-6932-2004-581925918E5D}" dt="2024-03-25T13:01:42.097" v="5"/>
          <ac:spMkLst>
            <pc:docMk/>
            <pc:sldMk cId="2583475902" sldId="260"/>
            <ac:spMk id="5" creationId="{5179C87C-817F-FC72-C2C6-F28A23EA4311}"/>
          </ac:spMkLst>
        </pc:spChg>
      </pc:sldChg>
    </pc:docChg>
  </pc:docChgLst>
  <pc:docChgLst>
    <pc:chgData name="Serena Mucciolo" userId="ec261867-03e3-4d89-ac40-a7f885ff8342" providerId="ADAL" clId="{29EB202C-E59D-40CA-ADA8-5849B75CCB6B}"/>
    <pc:docChg chg="modSld">
      <pc:chgData name="Serena Mucciolo" userId="ec261867-03e3-4d89-ac40-a7f885ff8342" providerId="ADAL" clId="{29EB202C-E59D-40CA-ADA8-5849B75CCB6B}" dt="2024-03-26T13:03:10.212" v="5" actId="114"/>
      <pc:docMkLst>
        <pc:docMk/>
      </pc:docMkLst>
      <pc:sldChg chg="modSp mod">
        <pc:chgData name="Serena Mucciolo" userId="ec261867-03e3-4d89-ac40-a7f885ff8342" providerId="ADAL" clId="{29EB202C-E59D-40CA-ADA8-5849B75CCB6B}" dt="2024-03-26T13:03:10.212" v="5" actId="114"/>
        <pc:sldMkLst>
          <pc:docMk/>
          <pc:sldMk cId="3414299677" sldId="261"/>
        </pc:sldMkLst>
        <pc:spChg chg="mod">
          <ac:chgData name="Serena Mucciolo" userId="ec261867-03e3-4d89-ac40-a7f885ff8342" providerId="ADAL" clId="{29EB202C-E59D-40CA-ADA8-5849B75CCB6B}" dt="2024-03-26T13:03:10.212" v="5" actId="114"/>
          <ac:spMkLst>
            <pc:docMk/>
            <pc:sldMk cId="3414299677" sldId="261"/>
            <ac:spMk id="10" creationId="{E00E3E5E-C25E-6F7D-3DC3-1B29F849F32C}"/>
          </ac:spMkLst>
        </pc:spChg>
      </pc:sldChg>
    </pc:docChg>
  </pc:docChgLst>
  <pc:docChgLst>
    <pc:chgData name="Andrea Desiderato" userId="S::andrea.desiderato@biol.uni.lodz.pl::40e84efd-8fcc-4d6c-84f3-d542403075a3" providerId="AD" clId="Web-{32E9D7E3-8CFD-75CB-018A-55380A7264B8}"/>
    <pc:docChg chg="modSld sldOrd">
      <pc:chgData name="Andrea Desiderato" userId="S::andrea.desiderato@biol.uni.lodz.pl::40e84efd-8fcc-4d6c-84f3-d542403075a3" providerId="AD" clId="Web-{32E9D7E3-8CFD-75CB-018A-55380A7264B8}" dt="2024-03-26T14:59:44.932" v="407" actId="20577"/>
      <pc:docMkLst>
        <pc:docMk/>
      </pc:docMkLst>
      <pc:sldChg chg="ord">
        <pc:chgData name="Andrea Desiderato" userId="S::andrea.desiderato@biol.uni.lodz.pl::40e84efd-8fcc-4d6c-84f3-d542403075a3" providerId="AD" clId="Web-{32E9D7E3-8CFD-75CB-018A-55380A7264B8}" dt="2024-03-26T14:58:47.884" v="396"/>
        <pc:sldMkLst>
          <pc:docMk/>
          <pc:sldMk cId="3266043801" sldId="256"/>
        </pc:sldMkLst>
      </pc:sldChg>
      <pc:sldChg chg="addSp delSp modSp ord">
        <pc:chgData name="Andrea Desiderato" userId="S::andrea.desiderato@biol.uni.lodz.pl::40e84efd-8fcc-4d6c-84f3-d542403075a3" providerId="AD" clId="Web-{32E9D7E3-8CFD-75CB-018A-55380A7264B8}" dt="2024-03-26T14:59:22.510" v="401" actId="20577"/>
        <pc:sldMkLst>
          <pc:docMk/>
          <pc:sldMk cId="2445588320" sldId="257"/>
        </pc:sldMkLst>
        <pc:spChg chg="mod">
          <ac:chgData name="Andrea Desiderato" userId="S::andrea.desiderato@biol.uni.lodz.pl::40e84efd-8fcc-4d6c-84f3-d542403075a3" providerId="AD" clId="Web-{32E9D7E3-8CFD-75CB-018A-55380A7264B8}" dt="2024-03-26T14:59:22.510" v="401" actId="20577"/>
          <ac:spMkLst>
            <pc:docMk/>
            <pc:sldMk cId="2445588320" sldId="257"/>
            <ac:spMk id="5" creationId="{5179C87C-817F-FC72-C2C6-F28A23EA4311}"/>
          </ac:spMkLst>
        </pc:spChg>
        <pc:picChg chg="del mod">
          <ac:chgData name="Andrea Desiderato" userId="S::andrea.desiderato@biol.uni.lodz.pl::40e84efd-8fcc-4d6c-84f3-d542403075a3" providerId="AD" clId="Web-{32E9D7E3-8CFD-75CB-018A-55380A7264B8}" dt="2024-03-26T14:53:26.013" v="345"/>
          <ac:picMkLst>
            <pc:docMk/>
            <pc:sldMk cId="2445588320" sldId="257"/>
            <ac:picMk id="2" creationId="{6BC954BD-44A8-0112-2F64-0F83D6EE9E96}"/>
          </ac:picMkLst>
        </pc:picChg>
        <pc:picChg chg="add mod">
          <ac:chgData name="Andrea Desiderato" userId="S::andrea.desiderato@biol.uni.lodz.pl::40e84efd-8fcc-4d6c-84f3-d542403075a3" providerId="AD" clId="Web-{32E9D7E3-8CFD-75CB-018A-55380A7264B8}" dt="2024-03-26T14:53:53.030" v="352" actId="1076"/>
          <ac:picMkLst>
            <pc:docMk/>
            <pc:sldMk cId="2445588320" sldId="257"/>
            <ac:picMk id="3" creationId="{A1F3F3EB-45C4-CC6E-31B4-1F3F87ABD4BC}"/>
          </ac:picMkLst>
        </pc:picChg>
      </pc:sldChg>
      <pc:sldChg chg="addSp delSp modSp">
        <pc:chgData name="Andrea Desiderato" userId="S::andrea.desiderato@biol.uni.lodz.pl::40e84efd-8fcc-4d6c-84f3-d542403075a3" providerId="AD" clId="Web-{32E9D7E3-8CFD-75CB-018A-55380A7264B8}" dt="2024-03-26T14:56:21.675" v="387" actId="20577"/>
        <pc:sldMkLst>
          <pc:docMk/>
          <pc:sldMk cId="1199539339" sldId="258"/>
        </pc:sldMkLst>
        <pc:spChg chg="mod">
          <ac:chgData name="Andrea Desiderato" userId="S::andrea.desiderato@biol.uni.lodz.pl::40e84efd-8fcc-4d6c-84f3-d542403075a3" providerId="AD" clId="Web-{32E9D7E3-8CFD-75CB-018A-55380A7264B8}" dt="2024-03-26T14:56:21.675" v="387" actId="20577"/>
          <ac:spMkLst>
            <pc:docMk/>
            <pc:sldMk cId="1199539339" sldId="258"/>
            <ac:spMk id="5" creationId="{5179C87C-817F-FC72-C2C6-F28A23EA4311}"/>
          </ac:spMkLst>
        </pc:spChg>
        <pc:picChg chg="add mod">
          <ac:chgData name="Andrea Desiderato" userId="S::andrea.desiderato@biol.uni.lodz.pl::40e84efd-8fcc-4d6c-84f3-d542403075a3" providerId="AD" clId="Web-{32E9D7E3-8CFD-75CB-018A-55380A7264B8}" dt="2024-03-26T14:54:18.906" v="357" actId="1076"/>
          <ac:picMkLst>
            <pc:docMk/>
            <pc:sldMk cId="1199539339" sldId="258"/>
            <ac:picMk id="2" creationId="{2F825078-189A-B323-1F35-0BE45B5CA0EF}"/>
          </ac:picMkLst>
        </pc:picChg>
        <pc:picChg chg="del mod">
          <ac:chgData name="Andrea Desiderato" userId="S::andrea.desiderato@biol.uni.lodz.pl::40e84efd-8fcc-4d6c-84f3-d542403075a3" providerId="AD" clId="Web-{32E9D7E3-8CFD-75CB-018A-55380A7264B8}" dt="2024-03-26T14:54:13.015" v="354"/>
          <ac:picMkLst>
            <pc:docMk/>
            <pc:sldMk cId="1199539339" sldId="258"/>
            <ac:picMk id="3" creationId="{CE2EE428-158B-9A2D-FAC5-45AA805476E4}"/>
          </ac:picMkLst>
        </pc:picChg>
      </pc:sldChg>
      <pc:sldChg chg="addSp delSp modSp">
        <pc:chgData name="Andrea Desiderato" userId="S::andrea.desiderato@biol.uni.lodz.pl::40e84efd-8fcc-4d6c-84f3-d542403075a3" providerId="AD" clId="Web-{32E9D7E3-8CFD-75CB-018A-55380A7264B8}" dt="2024-03-26T14:59:44.932" v="407" actId="20577"/>
        <pc:sldMkLst>
          <pc:docMk/>
          <pc:sldMk cId="127903412" sldId="259"/>
        </pc:sldMkLst>
        <pc:spChg chg="mod">
          <ac:chgData name="Andrea Desiderato" userId="S::andrea.desiderato@biol.uni.lodz.pl::40e84efd-8fcc-4d6c-84f3-d542403075a3" providerId="AD" clId="Web-{32E9D7E3-8CFD-75CB-018A-55380A7264B8}" dt="2024-03-26T14:59:44.932" v="407" actId="20577"/>
          <ac:spMkLst>
            <pc:docMk/>
            <pc:sldMk cId="127903412" sldId="259"/>
            <ac:spMk id="5" creationId="{5179C87C-817F-FC72-C2C6-F28A23EA4311}"/>
          </ac:spMkLst>
        </pc:spChg>
        <pc:picChg chg="add del mod">
          <ac:chgData name="Andrea Desiderato" userId="S::andrea.desiderato@biol.uni.lodz.pl::40e84efd-8fcc-4d6c-84f3-d542403075a3" providerId="AD" clId="Web-{32E9D7E3-8CFD-75CB-018A-55380A7264B8}" dt="2024-03-26T14:57:37.131" v="389"/>
          <ac:picMkLst>
            <pc:docMk/>
            <pc:sldMk cId="127903412" sldId="259"/>
            <ac:picMk id="2" creationId="{1BE7A0DE-48AA-F214-AF3E-ADE7BBFD112C}"/>
          </ac:picMkLst>
        </pc:picChg>
        <pc:picChg chg="del mod">
          <ac:chgData name="Andrea Desiderato" userId="S::andrea.desiderato@biol.uni.lodz.pl::40e84efd-8fcc-4d6c-84f3-d542403075a3" providerId="AD" clId="Web-{32E9D7E3-8CFD-75CB-018A-55380A7264B8}" dt="2024-03-26T14:58:23.476" v="390"/>
          <ac:picMkLst>
            <pc:docMk/>
            <pc:sldMk cId="127903412" sldId="259"/>
            <ac:picMk id="3" creationId="{782D1D09-AAA4-DADF-F810-EE91E13A5DE7}"/>
          </ac:picMkLst>
        </pc:picChg>
        <pc:picChg chg="add mod">
          <ac:chgData name="Andrea Desiderato" userId="S::andrea.desiderato@biol.uni.lodz.pl::40e84efd-8fcc-4d6c-84f3-d542403075a3" providerId="AD" clId="Web-{32E9D7E3-8CFD-75CB-018A-55380A7264B8}" dt="2024-03-26T14:58:41.930" v="395" actId="1076"/>
          <ac:picMkLst>
            <pc:docMk/>
            <pc:sldMk cId="127903412" sldId="259"/>
            <ac:picMk id="4" creationId="{651861C7-EEE5-2A3F-CED6-6F92246A71BD}"/>
          </ac:picMkLst>
        </pc:picChg>
      </pc:sldChg>
      <pc:sldChg chg="addSp delSp modSp">
        <pc:chgData name="Andrea Desiderato" userId="S::andrea.desiderato@biol.uni.lodz.pl::40e84efd-8fcc-4d6c-84f3-d542403075a3" providerId="AD" clId="Web-{32E9D7E3-8CFD-75CB-018A-55380A7264B8}" dt="2024-03-26T14:50:05.819" v="329" actId="1076"/>
        <pc:sldMkLst>
          <pc:docMk/>
          <pc:sldMk cId="2583475902" sldId="260"/>
        </pc:sldMkLst>
        <pc:spChg chg="mod">
          <ac:chgData name="Andrea Desiderato" userId="S::andrea.desiderato@biol.uni.lodz.pl::40e84efd-8fcc-4d6c-84f3-d542403075a3" providerId="AD" clId="Web-{32E9D7E3-8CFD-75CB-018A-55380A7264B8}" dt="2024-03-26T14:50:00.287" v="328" actId="20577"/>
          <ac:spMkLst>
            <pc:docMk/>
            <pc:sldMk cId="2583475902" sldId="260"/>
            <ac:spMk id="5" creationId="{5179C87C-817F-FC72-C2C6-F28A23EA4311}"/>
          </ac:spMkLst>
        </pc:spChg>
        <pc:picChg chg="add del mod">
          <ac:chgData name="Andrea Desiderato" userId="S::andrea.desiderato@biol.uni.lodz.pl::40e84efd-8fcc-4d6c-84f3-d542403075a3" providerId="AD" clId="Web-{32E9D7E3-8CFD-75CB-018A-55380A7264B8}" dt="2024-03-26T14:46:45.062" v="11"/>
          <ac:picMkLst>
            <pc:docMk/>
            <pc:sldMk cId="2583475902" sldId="260"/>
            <ac:picMk id="2" creationId="{6AFEA5E1-35C9-CA97-86A1-2CCD820DDB40}"/>
          </ac:picMkLst>
        </pc:picChg>
        <pc:picChg chg="del mod">
          <ac:chgData name="Andrea Desiderato" userId="S::andrea.desiderato@biol.uni.lodz.pl::40e84efd-8fcc-4d6c-84f3-d542403075a3" providerId="AD" clId="Web-{32E9D7E3-8CFD-75CB-018A-55380A7264B8}" dt="2024-03-26T14:46:33.171" v="9"/>
          <ac:picMkLst>
            <pc:docMk/>
            <pc:sldMk cId="2583475902" sldId="260"/>
            <ac:picMk id="3" creationId="{B06EA449-D552-DABD-11CC-BDFDEB9A3526}"/>
          </ac:picMkLst>
        </pc:picChg>
        <pc:picChg chg="add mod">
          <ac:chgData name="Andrea Desiderato" userId="S::andrea.desiderato@biol.uni.lodz.pl::40e84efd-8fcc-4d6c-84f3-d542403075a3" providerId="AD" clId="Web-{32E9D7E3-8CFD-75CB-018A-55380A7264B8}" dt="2024-03-26T14:50:05.819" v="329" actId="1076"/>
          <ac:picMkLst>
            <pc:docMk/>
            <pc:sldMk cId="2583475902" sldId="260"/>
            <ac:picMk id="4" creationId="{20BB1579-E9BA-841F-CCCF-B6D237C39E52}"/>
          </ac:picMkLst>
        </pc:picChg>
      </pc:sldChg>
    </pc:docChg>
  </pc:docChgLst>
  <pc:docChgLst>
    <pc:chgData name="Andrea Desiderato" userId="S::andrea.desiderato@biol.uni.lodz.pl::40e84efd-8fcc-4d6c-84f3-d542403075a3" providerId="AD" clId="Web-{C0148E8F-5CF9-999B-CAD0-99853277057E}"/>
    <pc:docChg chg="modSld">
      <pc:chgData name="Andrea Desiderato" userId="S::andrea.desiderato@biol.uni.lodz.pl::40e84efd-8fcc-4d6c-84f3-d542403075a3" providerId="AD" clId="Web-{C0148E8F-5CF9-999B-CAD0-99853277057E}" dt="2024-03-27T09:04:53.815" v="68" actId="1076"/>
      <pc:docMkLst>
        <pc:docMk/>
      </pc:docMkLst>
      <pc:sldChg chg="addSp modSp">
        <pc:chgData name="Andrea Desiderato" userId="S::andrea.desiderato@biol.uni.lodz.pl::40e84efd-8fcc-4d6c-84f3-d542403075a3" providerId="AD" clId="Web-{C0148E8F-5CF9-999B-CAD0-99853277057E}" dt="2024-03-27T08:18:02.878" v="42" actId="20577"/>
        <pc:sldMkLst>
          <pc:docMk/>
          <pc:sldMk cId="2445588320" sldId="257"/>
        </pc:sldMkLst>
        <pc:spChg chg="mod">
          <ac:chgData name="Andrea Desiderato" userId="S::andrea.desiderato@biol.uni.lodz.pl::40e84efd-8fcc-4d6c-84f3-d542403075a3" providerId="AD" clId="Web-{C0148E8F-5CF9-999B-CAD0-99853277057E}" dt="2024-03-27T08:18:02.878" v="42" actId="20577"/>
          <ac:spMkLst>
            <pc:docMk/>
            <pc:sldMk cId="2445588320" sldId="257"/>
            <ac:spMk id="5" creationId="{5179C87C-817F-FC72-C2C6-F28A23EA4311}"/>
          </ac:spMkLst>
        </pc:spChg>
        <pc:picChg chg="add mod">
          <ac:chgData name="Andrea Desiderato" userId="S::andrea.desiderato@biol.uni.lodz.pl::40e84efd-8fcc-4d6c-84f3-d542403075a3" providerId="AD" clId="Web-{C0148E8F-5CF9-999B-CAD0-99853277057E}" dt="2024-03-27T08:16:46.342" v="2" actId="14100"/>
          <ac:picMkLst>
            <pc:docMk/>
            <pc:sldMk cId="2445588320" sldId="257"/>
            <ac:picMk id="2" creationId="{67DF9848-B0D9-DCFF-C568-D35DB477D213}"/>
          </ac:picMkLst>
        </pc:picChg>
      </pc:sldChg>
      <pc:sldChg chg="addSp delSp modSp">
        <pc:chgData name="Andrea Desiderato" userId="S::andrea.desiderato@biol.uni.lodz.pl::40e84efd-8fcc-4d6c-84f3-d542403075a3" providerId="AD" clId="Web-{C0148E8F-5CF9-999B-CAD0-99853277057E}" dt="2024-03-27T08:21:37.986" v="55" actId="1076"/>
        <pc:sldMkLst>
          <pc:docMk/>
          <pc:sldMk cId="1199539339" sldId="258"/>
        </pc:sldMkLst>
        <pc:spChg chg="mod">
          <ac:chgData name="Andrea Desiderato" userId="S::andrea.desiderato@biol.uni.lodz.pl::40e84efd-8fcc-4d6c-84f3-d542403075a3" providerId="AD" clId="Web-{C0148E8F-5CF9-999B-CAD0-99853277057E}" dt="2024-03-27T08:17:57.643" v="40" actId="20577"/>
          <ac:spMkLst>
            <pc:docMk/>
            <pc:sldMk cId="1199539339" sldId="258"/>
            <ac:spMk id="5" creationId="{5179C87C-817F-FC72-C2C6-F28A23EA4311}"/>
          </ac:spMkLst>
        </pc:spChg>
        <pc:picChg chg="del">
          <ac:chgData name="Andrea Desiderato" userId="S::andrea.desiderato@biol.uni.lodz.pl::40e84efd-8fcc-4d6c-84f3-d542403075a3" providerId="AD" clId="Web-{C0148E8F-5CF9-999B-CAD0-99853277057E}" dt="2024-03-27T08:18:21.176" v="50"/>
          <ac:picMkLst>
            <pc:docMk/>
            <pc:sldMk cId="1199539339" sldId="258"/>
            <ac:picMk id="2" creationId="{2F825078-189A-B323-1F35-0BE45B5CA0EF}"/>
          </ac:picMkLst>
        </pc:picChg>
        <pc:picChg chg="add mod">
          <ac:chgData name="Andrea Desiderato" userId="S::andrea.desiderato@biol.uni.lodz.pl::40e84efd-8fcc-4d6c-84f3-d542403075a3" providerId="AD" clId="Web-{C0148E8F-5CF9-999B-CAD0-99853277057E}" dt="2024-03-27T08:21:37.986" v="55" actId="1076"/>
          <ac:picMkLst>
            <pc:docMk/>
            <pc:sldMk cId="1199539339" sldId="258"/>
            <ac:picMk id="3" creationId="{CD83A330-0921-CCA3-3BD1-E93A8D79028E}"/>
          </ac:picMkLst>
        </pc:picChg>
      </pc:sldChg>
      <pc:sldChg chg="addSp delSp modSp">
        <pc:chgData name="Andrea Desiderato" userId="S::andrea.desiderato@biol.uni.lodz.pl::40e84efd-8fcc-4d6c-84f3-d542403075a3" providerId="AD" clId="Web-{C0148E8F-5CF9-999B-CAD0-99853277057E}" dt="2024-03-27T08:33:23.299" v="59" actId="1076"/>
        <pc:sldMkLst>
          <pc:docMk/>
          <pc:sldMk cId="127903412" sldId="259"/>
        </pc:sldMkLst>
        <pc:spChg chg="mod">
          <ac:chgData name="Andrea Desiderato" userId="S::andrea.desiderato@biol.uni.lodz.pl::40e84efd-8fcc-4d6c-84f3-d542403075a3" providerId="AD" clId="Web-{C0148E8F-5CF9-999B-CAD0-99853277057E}" dt="2024-03-27T08:18:09.457" v="44" actId="20577"/>
          <ac:spMkLst>
            <pc:docMk/>
            <pc:sldMk cId="127903412" sldId="259"/>
            <ac:spMk id="5" creationId="{5179C87C-817F-FC72-C2C6-F28A23EA4311}"/>
          </ac:spMkLst>
        </pc:spChg>
        <pc:picChg chg="add mod">
          <ac:chgData name="Andrea Desiderato" userId="S::andrea.desiderato@biol.uni.lodz.pl::40e84efd-8fcc-4d6c-84f3-d542403075a3" providerId="AD" clId="Web-{C0148E8F-5CF9-999B-CAD0-99853277057E}" dt="2024-03-27T08:33:23.299" v="59" actId="1076"/>
          <ac:picMkLst>
            <pc:docMk/>
            <pc:sldMk cId="127903412" sldId="259"/>
            <ac:picMk id="2" creationId="{CC4C5903-E4E0-2E73-292D-196CFA30F8D8}"/>
          </ac:picMkLst>
        </pc:picChg>
        <pc:picChg chg="del">
          <ac:chgData name="Andrea Desiderato" userId="S::andrea.desiderato@biol.uni.lodz.pl::40e84efd-8fcc-4d6c-84f3-d542403075a3" providerId="AD" clId="Web-{C0148E8F-5CF9-999B-CAD0-99853277057E}" dt="2024-03-27T08:18:19.254" v="49"/>
          <ac:picMkLst>
            <pc:docMk/>
            <pc:sldMk cId="127903412" sldId="259"/>
            <ac:picMk id="4" creationId="{651861C7-EEE5-2A3F-CED6-6F92246A71BD}"/>
          </ac:picMkLst>
        </pc:picChg>
      </pc:sldChg>
      <pc:sldChg chg="addSp delSp modSp">
        <pc:chgData name="Andrea Desiderato" userId="S::andrea.desiderato@biol.uni.lodz.pl::40e84efd-8fcc-4d6c-84f3-d542403075a3" providerId="AD" clId="Web-{C0148E8F-5CF9-999B-CAD0-99853277057E}" dt="2024-03-27T09:04:53.815" v="68" actId="1076"/>
        <pc:sldMkLst>
          <pc:docMk/>
          <pc:sldMk cId="2583475902" sldId="260"/>
        </pc:sldMkLst>
        <pc:spChg chg="mod">
          <ac:chgData name="Andrea Desiderato" userId="S::andrea.desiderato@biol.uni.lodz.pl::40e84efd-8fcc-4d6c-84f3-d542403075a3" providerId="AD" clId="Web-{C0148E8F-5CF9-999B-CAD0-99853277057E}" dt="2024-03-27T08:40:26.578" v="64" actId="20577"/>
          <ac:spMkLst>
            <pc:docMk/>
            <pc:sldMk cId="2583475902" sldId="260"/>
            <ac:spMk id="5" creationId="{5179C87C-817F-FC72-C2C6-F28A23EA4311}"/>
          </ac:spMkLst>
        </pc:spChg>
        <pc:picChg chg="add mod">
          <ac:chgData name="Andrea Desiderato" userId="S::andrea.desiderato@biol.uni.lodz.pl::40e84efd-8fcc-4d6c-84f3-d542403075a3" providerId="AD" clId="Web-{C0148E8F-5CF9-999B-CAD0-99853277057E}" dt="2024-03-27T09:04:53.815" v="68" actId="1076"/>
          <ac:picMkLst>
            <pc:docMk/>
            <pc:sldMk cId="2583475902" sldId="260"/>
            <ac:picMk id="2" creationId="{A5C6CDD2-B2F4-6FB4-4BE2-28F602BF89D3}"/>
          </ac:picMkLst>
        </pc:picChg>
        <pc:picChg chg="del mod">
          <ac:chgData name="Andrea Desiderato" userId="S::andrea.desiderato@biol.uni.lodz.pl::40e84efd-8fcc-4d6c-84f3-d542403075a3" providerId="AD" clId="Web-{C0148E8F-5CF9-999B-CAD0-99853277057E}" dt="2024-03-27T08:18:22.629" v="51"/>
          <ac:picMkLst>
            <pc:docMk/>
            <pc:sldMk cId="2583475902" sldId="260"/>
            <ac:picMk id="4" creationId="{20BB1579-E9BA-841F-CCCF-B6D237C39E52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F8896E-D2D7-4AD6-8B9B-97F5C5915D4B}" type="datetimeFigureOut">
              <a:rPr lang="pt-BR" smtClean="0"/>
              <a:t>27/03/2024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8AC763-1C1E-47C6-956C-DDD06B421FA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673451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8AC763-1C1E-47C6-956C-DDD06B421FA8}" type="slidenum">
              <a:rPr lang="pt-BR" smtClean="0"/>
              <a:t>2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727147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4B28365-AFB0-C6BA-97F9-F3F9849526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984BCBC9-BD86-E088-999A-F60BC1AF20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52764CAD-80E4-1A9F-8B67-457A6EC612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8D984-3EE2-4D2C-8412-D095052157E4}" type="datetimeFigureOut">
              <a:rPr lang="pt-BR" smtClean="0"/>
              <a:t>27/03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AF70E5F-BC15-F861-0845-002438B6D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618EABC-F924-00A0-EF51-D51F4DB0E3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44CA-E6CC-4BBB-858C-20A714A654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782993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4DB697A-3DA1-1088-9FA3-45C8DD1A39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4D4CDFC6-0ED4-7743-E166-C2CCF72284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40A2AC9-7EE6-A983-BE7F-1ED80AB289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8D984-3EE2-4D2C-8412-D095052157E4}" type="datetimeFigureOut">
              <a:rPr lang="pt-BR" smtClean="0"/>
              <a:t>27/03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AF38C491-2D12-10E6-F560-E3F51D1693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B1EA1A1-C23A-3B7A-622F-74BFB9E3A7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44CA-E6CC-4BBB-858C-20A714A654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98268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DDB0CCB7-7119-AE7A-1291-7F835E4529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F02B5DA6-20C8-F908-DDB4-217A9C5430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8ADEFA15-D5D2-26F5-0C84-6CD707E2CD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8D984-3EE2-4D2C-8412-D095052157E4}" type="datetimeFigureOut">
              <a:rPr lang="pt-BR" smtClean="0"/>
              <a:t>27/03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9B9AD65-79A2-F10B-4513-7305FDA237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4422AA8-0194-6027-25B5-2F0214DF3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44CA-E6CC-4BBB-858C-20A714A654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39353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3EEBD5C-92D1-6C3A-EBFA-DD1B331E33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3FD9A094-584E-50A2-C1BA-E33C02356A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D18DEBE-0730-B42B-B1F6-24FBC4FFDB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8D984-3EE2-4D2C-8412-D095052157E4}" type="datetimeFigureOut">
              <a:rPr lang="pt-BR" smtClean="0"/>
              <a:t>27/03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B01F7AC-24DF-45F4-AA62-6D311643C6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E67949A-798E-0C3C-E3A3-341249BE4A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44CA-E6CC-4BBB-858C-20A714A654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144600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8B12B5C-6F9F-1188-562C-2C38B2439E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531E96F3-3693-467F-F6FC-D5E9FAF590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B451F955-49B8-7836-4FB0-8BB70A76C0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8D984-3EE2-4D2C-8412-D095052157E4}" type="datetimeFigureOut">
              <a:rPr lang="pt-BR" smtClean="0"/>
              <a:t>27/03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C1A26EB-E250-7F3E-2B60-5A2BAB825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6B7BFAD0-D925-2F57-2F9D-4E669F8744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44CA-E6CC-4BBB-858C-20A714A654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19472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55CDD87-DAD5-D721-AA5F-FB4BF6F1CB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1C25C499-203C-4A65-4021-BD42EEECB7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CF4961D0-A673-DEE8-95E0-DE6DD2955A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8C5ECF0E-7461-BAF2-3DDA-7A49360FD0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8D984-3EE2-4D2C-8412-D095052157E4}" type="datetimeFigureOut">
              <a:rPr lang="pt-BR" smtClean="0"/>
              <a:t>27/03/2024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3026B1B7-4AAC-EB1D-FA52-EADEB233E2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186E7D6D-7296-F6B8-FC41-57E53E9B5F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44CA-E6CC-4BBB-858C-20A714A654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51996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03B55ED-996A-1D1E-E2AE-1B09A5E4A9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33CF7E36-2F3F-00A8-5C50-B1EADB0097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F718A291-2193-366E-992D-48AAE47621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0C28F99B-C35D-C948-11C7-18A3EDE6B4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18EACA50-419E-72BF-0F00-888D6DBABBA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484AFA59-4DAA-4C4A-D6B2-CC6C034D5D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8D984-3EE2-4D2C-8412-D095052157E4}" type="datetimeFigureOut">
              <a:rPr lang="pt-BR" smtClean="0"/>
              <a:t>27/03/2024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B5E3F3A4-7BBD-3CAF-71C0-E3F18432C7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AAB67D68-4C11-BA96-CF38-AEBCE58F47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44CA-E6CC-4BBB-858C-20A714A654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74300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2528A29-AF90-83C2-9B0C-72B578DEF0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7AD8827D-B0AA-079B-884D-EA16DF3B70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8D984-3EE2-4D2C-8412-D095052157E4}" type="datetimeFigureOut">
              <a:rPr lang="pt-BR" smtClean="0"/>
              <a:t>27/03/2024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40404C9A-21DD-78E8-0921-2C0F04DBF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F0004DDE-83E8-8681-1D86-B7F168F746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44CA-E6CC-4BBB-858C-20A714A654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276140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822EEA35-A5A5-98E6-B672-37AEBB9FA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8D984-3EE2-4D2C-8412-D095052157E4}" type="datetimeFigureOut">
              <a:rPr lang="pt-BR" smtClean="0"/>
              <a:t>27/03/2024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034AC140-DFDD-1AFD-391E-419F46A0C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6F876B4B-3F9B-96B8-3055-A7C7ECE5A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44CA-E6CC-4BBB-858C-20A714A654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44000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3BECB0D-9931-E887-B304-861766EE4E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03A43537-31FA-0E23-31B6-EB6260CC8B6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84F3E396-69EA-4BD5-66D4-76ABC5D287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453ED183-40DA-AADE-F56E-489B1F3AA4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8D984-3EE2-4D2C-8412-D095052157E4}" type="datetimeFigureOut">
              <a:rPr lang="pt-BR" smtClean="0"/>
              <a:t>27/03/2024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86CCAA9A-2DC7-BF55-5BF5-CFF5C7A87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A486D98C-2B1C-A014-58C4-5E4BB22EE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44CA-E6CC-4BBB-858C-20A714A654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28906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B4FA20D-57EB-1D41-D886-96C61C3285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EB129D2D-9363-F96A-1815-C14C52038B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C2A9FACB-4648-DBFF-EE86-E93A59272D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912FBDA0-AF45-9052-4FC2-38B8F138A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8D984-3EE2-4D2C-8412-D095052157E4}" type="datetimeFigureOut">
              <a:rPr lang="pt-BR" smtClean="0"/>
              <a:t>27/03/2024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7C6430BF-B264-BFC6-5916-484FDCE9C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C886B7C3-CCFD-A305-C85C-C4298B5ADF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44CA-E6CC-4BBB-858C-20A714A654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27556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9117BB52-2B1F-7E63-2709-D45D6A588F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81D1DC06-9E85-85D3-CBCA-EA6F3AB057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A120B149-970D-E217-ADB5-2D53353196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18D984-3EE2-4D2C-8412-D095052157E4}" type="datetimeFigureOut">
              <a:rPr lang="pt-BR" smtClean="0"/>
              <a:t>27/03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16C2E50-6186-589A-FB98-1D7FDC62AF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96B2F79-AD60-CC5B-150E-7617769CC5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5144CA-E6CC-4BBB-858C-20A714A654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34394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agem 8">
            <a:extLst>
              <a:ext uri="{FF2B5EF4-FFF2-40B4-BE49-F238E27FC236}">
                <a16:creationId xmlns:a16="http://schemas.microsoft.com/office/drawing/2014/main" id="{628F937C-7A04-BEC4-8F2A-2D16651A5B7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57" t="1525" r="16964" b="10286"/>
          <a:stretch/>
        </p:blipFill>
        <p:spPr>
          <a:xfrm>
            <a:off x="165048" y="1381090"/>
            <a:ext cx="6272891" cy="4737927"/>
          </a:xfrm>
          <a:prstGeom prst="rect">
            <a:avLst/>
          </a:prstGeom>
        </p:spPr>
      </p:pic>
      <p:sp>
        <p:nvSpPr>
          <p:cNvPr id="10" name="CaixaDeTexto 9">
            <a:extLst>
              <a:ext uri="{FF2B5EF4-FFF2-40B4-BE49-F238E27FC236}">
                <a16:creationId xmlns:a16="http://schemas.microsoft.com/office/drawing/2014/main" id="{E00E3E5E-C25E-6F7D-3DC3-1B29F849F32C}"/>
              </a:ext>
            </a:extLst>
          </p:cNvPr>
          <p:cNvSpPr txBox="1"/>
          <p:nvPr/>
        </p:nvSpPr>
        <p:spPr>
          <a:xfrm>
            <a:off x="22408" y="117566"/>
            <a:ext cx="12192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</a:t>
            </a:r>
            <a:r>
              <a:rPr lang="en-GB" sz="140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gittal sections showing</a:t>
            </a:r>
            <a:r>
              <a:rPr lang="en-GB" sz="1400" b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40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munofluorescence signals and negative control for </a:t>
            </a:r>
            <a:r>
              <a:rPr lang="en-GB" sz="1400" i="1" err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itta</a:t>
            </a:r>
            <a:r>
              <a:rPr lang="en-GB" sz="1400" i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400" i="1" err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yarae</a:t>
            </a:r>
            <a:r>
              <a:rPr lang="en-GB" sz="140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A-E) and </a:t>
            </a:r>
            <a:r>
              <a:rPr lang="en-GB" sz="1400" i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. acuta. </a:t>
            </a:r>
            <a:r>
              <a:rPr lang="en-GB" sz="140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F-I)</a:t>
            </a:r>
            <a:r>
              <a:rPr lang="en-GB" sz="1400" i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400" i="1" err="1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itta</a:t>
            </a:r>
            <a:r>
              <a:rPr lang="en-GB" sz="1400" i="1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400" i="1" err="1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yarae</a:t>
            </a:r>
            <a:r>
              <a:rPr lang="en-GB" sz="1400" i="1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GB" sz="140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KCC signal i</a:t>
            </a:r>
            <a:r>
              <a:rPr lang="en-GB" sz="140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 A-D, negative control in E; </a:t>
            </a:r>
            <a:r>
              <a:rPr lang="en-GB" sz="1400" i="1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. acuta</a:t>
            </a:r>
            <a:r>
              <a:rPr lang="en-GB" sz="140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NKCC signal in F-H, negative control in I.</a:t>
            </a:r>
            <a:r>
              <a:rPr lang="en-GB" sz="1400" i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40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bbreviations: ep= internal epithelium; int= integument; m= muscles. </a:t>
            </a:r>
            <a:endParaRPr lang="en-GB" sz="1400" i="1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GB" sz="1400" i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ale bars: 160 µm.</a:t>
            </a:r>
            <a:endParaRPr lang="pt-BR" sz="1400">
              <a:solidFill>
                <a:schemeClr val="bg1"/>
              </a:solidFill>
            </a:endParaRPr>
          </a:p>
        </p:txBody>
      </p:sp>
      <p:pic>
        <p:nvPicPr>
          <p:cNvPr id="16" name="Imagem 15">
            <a:extLst>
              <a:ext uri="{FF2B5EF4-FFF2-40B4-BE49-F238E27FC236}">
                <a16:creationId xmlns:a16="http://schemas.microsoft.com/office/drawing/2014/main" id="{B5D06C7C-07BB-07E0-AED8-AC9BB032027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90" t="1714" r="34310" b="7866"/>
          <a:stretch/>
        </p:blipFill>
        <p:spPr>
          <a:xfrm>
            <a:off x="6437939" y="856230"/>
            <a:ext cx="5726753" cy="5884204"/>
          </a:xfrm>
          <a:prstGeom prst="rect">
            <a:avLst/>
          </a:prstGeom>
        </p:spPr>
      </p:pic>
      <p:cxnSp>
        <p:nvCxnSpPr>
          <p:cNvPr id="17" name="Conector reto 16">
            <a:extLst>
              <a:ext uri="{FF2B5EF4-FFF2-40B4-BE49-F238E27FC236}">
                <a16:creationId xmlns:a16="http://schemas.microsoft.com/office/drawing/2014/main" id="{0A7B88BE-26B4-F4A8-62B9-A4DFB254333C}"/>
              </a:ext>
            </a:extLst>
          </p:cNvPr>
          <p:cNvCxnSpPr>
            <a:cxnSpLocks/>
          </p:cNvCxnSpPr>
          <p:nvPr/>
        </p:nvCxnSpPr>
        <p:spPr>
          <a:xfrm>
            <a:off x="6401641" y="927462"/>
            <a:ext cx="0" cy="5904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142996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Imagem 16">
            <a:extLst>
              <a:ext uri="{FF2B5EF4-FFF2-40B4-BE49-F238E27FC236}">
                <a16:creationId xmlns:a16="http://schemas.microsoft.com/office/drawing/2014/main" id="{FA8600F7-D113-2D99-F9D2-C54D7F68FDE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76" t="5775" r="29451"/>
          <a:stretch/>
        </p:blipFill>
        <p:spPr>
          <a:xfrm>
            <a:off x="0" y="1063692"/>
            <a:ext cx="5838271" cy="5528348"/>
          </a:xfrm>
          <a:prstGeom prst="rect">
            <a:avLst/>
          </a:prstGeom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A5E7F107-340C-44F9-D47F-667FED8D7173}"/>
              </a:ext>
            </a:extLst>
          </p:cNvPr>
          <p:cNvSpPr txBox="1"/>
          <p:nvPr/>
        </p:nvSpPr>
        <p:spPr>
          <a:xfrm>
            <a:off x="22408" y="117566"/>
            <a:ext cx="12192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</a:t>
            </a:r>
            <a:r>
              <a:rPr lang="en-GB" sz="140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gittal sections showing</a:t>
            </a:r>
            <a:r>
              <a:rPr lang="en-GB" sz="1400" b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40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munofluorescence signals and negative control for </a:t>
            </a:r>
            <a:r>
              <a:rPr lang="en-GB" sz="1400" i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. </a:t>
            </a:r>
            <a:r>
              <a:rPr lang="en-GB" sz="1400" i="1" err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uviatilis</a:t>
            </a:r>
            <a:r>
              <a:rPr lang="en-GB" sz="1400" i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40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-D) and </a:t>
            </a:r>
            <a:r>
              <a:rPr lang="en-GB" sz="1400" i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. </a:t>
            </a:r>
            <a:r>
              <a:rPr lang="en-GB" sz="1400" i="1" err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ulchella</a:t>
            </a:r>
            <a:r>
              <a:rPr lang="en-GB" sz="1400" i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40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E-H)</a:t>
            </a:r>
            <a:r>
              <a:rPr lang="en-GB" sz="1400" i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400" i="1" err="1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phtys</a:t>
            </a:r>
            <a:r>
              <a:rPr lang="en-GB" sz="1400" i="1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400" i="1" err="1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uviatilis</a:t>
            </a:r>
            <a:r>
              <a:rPr lang="en-GB" sz="1400" i="1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GB" sz="140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KCC signal i</a:t>
            </a:r>
            <a:r>
              <a:rPr lang="en-GB" sz="140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 A-C, negative control in D; </a:t>
            </a:r>
            <a:r>
              <a:rPr lang="en-GB" sz="1400" i="1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. </a:t>
            </a:r>
            <a:r>
              <a:rPr lang="en-GB" sz="1400" i="1" err="1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ulchella</a:t>
            </a:r>
            <a:r>
              <a:rPr lang="en-GB" sz="140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NKCC signal in E-G, negative control in H.</a:t>
            </a:r>
            <a:r>
              <a:rPr lang="en-GB" sz="1400" i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40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s: </a:t>
            </a:r>
            <a:r>
              <a:rPr lang="en-GB" sz="1400" err="1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</a:t>
            </a:r>
            <a:r>
              <a:rPr lang="en-GB" sz="140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 branchiae; ep= internal epithelium; int= integument; m= muscles; per= peritoneum. </a:t>
            </a:r>
            <a:r>
              <a:rPr lang="en-GB" sz="1400" i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ale bars: 160 µm.</a:t>
            </a:r>
            <a:endParaRPr lang="en-GB" sz="1400" i="1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pt-BR" sz="1400">
              <a:solidFill>
                <a:schemeClr val="bg1"/>
              </a:solidFill>
            </a:endParaRPr>
          </a:p>
        </p:txBody>
      </p:sp>
      <p:pic>
        <p:nvPicPr>
          <p:cNvPr id="22" name="Imagem 21">
            <a:extLst>
              <a:ext uri="{FF2B5EF4-FFF2-40B4-BE49-F238E27FC236}">
                <a16:creationId xmlns:a16="http://schemas.microsoft.com/office/drawing/2014/main" id="{5B4CB70E-E66E-0039-3B39-AC82DD05D9D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77" r="14444"/>
          <a:stretch/>
        </p:blipFill>
        <p:spPr>
          <a:xfrm>
            <a:off x="5825208" y="1050629"/>
            <a:ext cx="6353729" cy="5441611"/>
          </a:xfrm>
          <a:prstGeom prst="rect">
            <a:avLst/>
          </a:prstGeom>
        </p:spPr>
      </p:pic>
      <p:cxnSp>
        <p:nvCxnSpPr>
          <p:cNvPr id="26" name="Conector reto 25">
            <a:extLst>
              <a:ext uri="{FF2B5EF4-FFF2-40B4-BE49-F238E27FC236}">
                <a16:creationId xmlns:a16="http://schemas.microsoft.com/office/drawing/2014/main" id="{0E82DBFC-1163-C87C-43C5-4573074F1BD3}"/>
              </a:ext>
            </a:extLst>
          </p:cNvPr>
          <p:cNvCxnSpPr>
            <a:cxnSpLocks/>
          </p:cNvCxnSpPr>
          <p:nvPr/>
        </p:nvCxnSpPr>
        <p:spPr>
          <a:xfrm>
            <a:off x="5802800" y="1149531"/>
            <a:ext cx="0" cy="566928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912529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m 3">
            <a:extLst>
              <a:ext uri="{FF2B5EF4-FFF2-40B4-BE49-F238E27FC236}">
                <a16:creationId xmlns:a16="http://schemas.microsoft.com/office/drawing/2014/main" id="{9EB263B7-57D8-D99E-13B0-83AB83485BC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2860" y="1288473"/>
            <a:ext cx="8872150" cy="5486399"/>
          </a:xfrm>
          <a:prstGeom prst="rect">
            <a:avLst/>
          </a:prstGeom>
        </p:spPr>
      </p:pic>
      <p:sp>
        <p:nvSpPr>
          <p:cNvPr id="5" name="CaixaDeTexto 4">
            <a:extLst>
              <a:ext uri="{FF2B5EF4-FFF2-40B4-BE49-F238E27FC236}">
                <a16:creationId xmlns:a16="http://schemas.microsoft.com/office/drawing/2014/main" id="{5179C87C-817F-FC72-C2C6-F28A23EA4311}"/>
              </a:ext>
            </a:extLst>
          </p:cNvPr>
          <p:cNvSpPr txBox="1"/>
          <p:nvPr/>
        </p:nvSpPr>
        <p:spPr>
          <a:xfrm>
            <a:off x="591515" y="198583"/>
            <a:ext cx="104648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 </a:t>
            </a:r>
            <a:r>
              <a:rPr lang="en-GB" sz="16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ylogenetic relationships of NKCC among metazoans. Maximum-likelihood (ML) analysis with 1,000 bootstrap replicates; tree rooted with the choanoflagellate sequences. Stars on branches referring to bootstrap values &gt;85%. Annelida sequences in blue-shaded box. Colours relative to different phyla.</a:t>
            </a:r>
            <a:endParaRPr lang="en-GB" sz="16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pt-BR" sz="1600"/>
          </a:p>
        </p:txBody>
      </p:sp>
    </p:spTree>
    <p:extLst>
      <p:ext uri="{BB962C8B-B14F-4D97-AF65-F5344CB8AC3E}">
        <p14:creationId xmlns:p14="http://schemas.microsoft.com/office/powerpoint/2010/main" val="32660438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5179C87C-817F-FC72-C2C6-F28A23EA4311}"/>
              </a:ext>
            </a:extLst>
          </p:cNvPr>
          <p:cNvSpPr txBox="1"/>
          <p:nvPr/>
        </p:nvSpPr>
        <p:spPr>
          <a:xfrm>
            <a:off x="591515" y="198583"/>
            <a:ext cx="10845800" cy="156966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1000"/>
              </a:spcAft>
            </a:pPr>
            <a:r>
              <a:rPr lang="en-GB" sz="1600" b="1" i="0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Figure S4. 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Boxplots of the variation of fluorescence intensity between the negative controls and the treatments in the annelid </a:t>
            </a:r>
            <a:r>
              <a:rPr lang="en-GB" sz="1600" i="1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Alitta </a:t>
            </a:r>
            <a:r>
              <a:rPr lang="en-GB" sz="1600" i="1" dirty="0" err="1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yarae</a:t>
            </a:r>
            <a:r>
              <a:rPr lang="en-GB" sz="1600" i="1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 </a:t>
            </a:r>
            <a:r>
              <a:rPr lang="en-GB" sz="16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in the two sessions of confocal (dates in top right corner). Significant comparisons with the negative control are represented with an asterisk, while letters refer to the pairwise comparison groups.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 Axis x: C= negative control (1, 2, depending on the confocal session), plus the location of the tissues retrieved with the specific signal. Colours refer to the negative control and the tissues: violet= negative control, black= cirri, yellow= integument, orange= muscles, light blue= inner epithelium (digestive). Axis y representing the intensity of the fluorescence converted in </a:t>
            </a:r>
            <a:r>
              <a:rPr lang="en-GB" sz="1600" i="0" dirty="0" err="1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gray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 value in each pixel².</a:t>
            </a:r>
            <a:endParaRPr lang="pt-BR" sz="1400" dirty="0">
              <a:solidFill>
                <a:srgbClr val="000000"/>
              </a:solidFill>
              <a:latin typeface="Times New Roman"/>
              <a:ea typeface="Calibri"/>
              <a:cs typeface="Times New Roman"/>
            </a:endParaRPr>
          </a:p>
        </p:txBody>
      </p:sp>
      <p:pic>
        <p:nvPicPr>
          <p:cNvPr id="2" name="Obraz 1" descr="Obraz zawierający zrzut ekranu&#10;&#10;Opis wygenerowany automatycznie">
            <a:extLst>
              <a:ext uri="{FF2B5EF4-FFF2-40B4-BE49-F238E27FC236}">
                <a16:creationId xmlns:a16="http://schemas.microsoft.com/office/drawing/2014/main" id="{67DF9848-B0D9-DCFF-C568-D35DB477D2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2544" y="1719440"/>
            <a:ext cx="9162361" cy="5075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55883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5179C87C-817F-FC72-C2C6-F28A23EA4311}"/>
              </a:ext>
            </a:extLst>
          </p:cNvPr>
          <p:cNvSpPr txBox="1"/>
          <p:nvPr/>
        </p:nvSpPr>
        <p:spPr>
          <a:xfrm>
            <a:off x="591515" y="198583"/>
            <a:ext cx="10464800" cy="165539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600" b="1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Figure S5.</a:t>
            </a:r>
            <a:r>
              <a:rPr lang="en-GB" sz="1600" b="1" dirty="0">
                <a:solidFill>
                  <a:srgbClr val="000000"/>
                </a:solidFill>
                <a:effectLst/>
                <a:latin typeface="Calibri"/>
                <a:ea typeface="Calibri"/>
                <a:cs typeface="Times New Roman"/>
              </a:rPr>
              <a:t> </a:t>
            </a:r>
            <a:r>
              <a:rPr lang="en-GB" sz="1600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Boxplots of the variation of fluorescence intensity between the negative controls and the treatments in the annelid </a:t>
            </a:r>
            <a:r>
              <a:rPr lang="en-GB" sz="1600" i="1" dirty="0" err="1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Laeonereis</a:t>
            </a:r>
            <a:r>
              <a:rPr lang="en-GB" sz="1600" i="1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 </a:t>
            </a:r>
            <a:r>
              <a:rPr lang="en-GB" sz="1600" i="1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acuta </a:t>
            </a:r>
            <a:r>
              <a:rPr lang="en-GB" sz="16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in the three sessions of confocal (dates in top right corner). Significant comparisons with the negative control represented with an asterisk, while letters refer to the pairwise comparison groups.</a:t>
            </a:r>
            <a:r>
              <a:rPr lang="en-GB" sz="1600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 Axis x: C= negative control (1-3, depending on the confocal session), plus the location of the tissues retrieved with the specific signal. Colours refer to the negative control and the tissues: violet= negative control, yellow= integument, orange= muscles. Axis y representing the intensity of the fluorescence converted in </a:t>
            </a:r>
            <a:r>
              <a:rPr lang="en-GB" sz="1600" dirty="0" err="1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gray</a:t>
            </a:r>
            <a:r>
              <a:rPr lang="en-GB" sz="1600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 value in each pixel².</a:t>
            </a:r>
          </a:p>
        </p:txBody>
      </p:sp>
      <p:pic>
        <p:nvPicPr>
          <p:cNvPr id="3" name="Obraz 2" descr="Obraz zawierający zrzut ekranu, kwadrat&#10;&#10;Opis wygenerowany automatycznie">
            <a:extLst>
              <a:ext uri="{FF2B5EF4-FFF2-40B4-BE49-F238E27FC236}">
                <a16:creationId xmlns:a16="http://schemas.microsoft.com/office/drawing/2014/main" id="{CD83A330-0921-CCA3-3BD1-E93A8D7902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1647" y="1944416"/>
            <a:ext cx="8473807" cy="47086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95393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5179C87C-817F-FC72-C2C6-F28A23EA4311}"/>
              </a:ext>
            </a:extLst>
          </p:cNvPr>
          <p:cNvSpPr txBox="1"/>
          <p:nvPr/>
        </p:nvSpPr>
        <p:spPr>
          <a:xfrm>
            <a:off x="591515" y="198583"/>
            <a:ext cx="10464800" cy="139192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600" b="1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Figure S6. </a:t>
            </a:r>
            <a:r>
              <a:rPr lang="en-GB" sz="1600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Boxplots of the variation of fluorescence intensity between the negative control and the treatments in the annelid </a:t>
            </a:r>
            <a:r>
              <a:rPr lang="en-GB" sz="1600" i="1" dirty="0" err="1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Nephtys</a:t>
            </a:r>
            <a:r>
              <a:rPr lang="en-GB" sz="1600" i="1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 </a:t>
            </a:r>
            <a:r>
              <a:rPr lang="en-GB" sz="1600" i="1" dirty="0" err="1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fluviatilis</a:t>
            </a:r>
            <a:r>
              <a:rPr lang="en-GB" sz="1600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. </a:t>
            </a:r>
            <a:r>
              <a:rPr lang="en-GB" sz="16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Significant comparisons with the negative control are represented with an asterisk, while letters refer to the pairwise comparison groups. </a:t>
            </a:r>
            <a:r>
              <a:rPr lang="en-GB" sz="1600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Axis x: C= negative control, plus the location of the tissues retrieved with the specific signal. Colours refer to the negative control and the tissues: violet= negative control, yellow= integument, orange= muscles, black= inner epithelium (peritoneum). Axis y representing the intensity of the fluorescence converted in </a:t>
            </a:r>
            <a:r>
              <a:rPr lang="en-GB" sz="1600" dirty="0" err="1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gray</a:t>
            </a:r>
            <a:r>
              <a:rPr lang="en-GB" sz="1600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 value in each pixel².</a:t>
            </a:r>
          </a:p>
        </p:txBody>
      </p:sp>
      <p:pic>
        <p:nvPicPr>
          <p:cNvPr id="2" name="Obraz 1" descr="Obraz zawierający zrzut ekranu, okno, kwadrat, Prostokąt&#10;&#10;Opis wygenerowany automatycznie">
            <a:extLst>
              <a:ext uri="{FF2B5EF4-FFF2-40B4-BE49-F238E27FC236}">
                <a16:creationId xmlns:a16="http://schemas.microsoft.com/office/drawing/2014/main" id="{CC4C5903-E4E0-2E73-292D-196CFA30F8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5994" y="1552738"/>
            <a:ext cx="9300072" cy="51677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9034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5179C87C-817F-FC72-C2C6-F28A23EA4311}"/>
              </a:ext>
            </a:extLst>
          </p:cNvPr>
          <p:cNvSpPr txBox="1"/>
          <p:nvPr/>
        </p:nvSpPr>
        <p:spPr>
          <a:xfrm>
            <a:off x="591515" y="198583"/>
            <a:ext cx="10464800" cy="192360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600" b="1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Figure S7.</a:t>
            </a:r>
            <a:r>
              <a:rPr lang="en-GB" sz="1600" dirty="0">
                <a:solidFill>
                  <a:srgbClr val="000000"/>
                </a:solidFill>
                <a:effectLst/>
                <a:latin typeface="Calibri"/>
                <a:ea typeface="Calibri"/>
                <a:cs typeface="Times New Roman"/>
              </a:rPr>
              <a:t> </a:t>
            </a:r>
            <a:r>
              <a:rPr lang="en-GB" sz="1600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Boxplots of the variation of fluorescence intensity between the negative controls and the treatments in the annelid </a:t>
            </a:r>
            <a:r>
              <a:rPr lang="en-GB" sz="1600" i="1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Isolda </a:t>
            </a:r>
            <a:r>
              <a:rPr lang="en-GB" sz="1600" i="1" dirty="0" err="1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pulchella</a:t>
            </a:r>
            <a:r>
              <a:rPr lang="en-GB" sz="1600" i="1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 </a:t>
            </a:r>
            <a:r>
              <a:rPr lang="en-GB" sz="16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in the two sessions of confocal (dates in top right corner).</a:t>
            </a:r>
            <a:r>
              <a:rPr lang="en-GB" sz="1600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 </a:t>
            </a:r>
            <a:r>
              <a:rPr lang="en-GB" sz="16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Significant comparisons with the negative control </a:t>
            </a:r>
            <a:r>
              <a:rPr lang="en-GB" sz="160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represented with an asterisk, while letters refer to the pairwise comparison groups. </a:t>
            </a:r>
            <a:r>
              <a:rPr lang="en-GB" sz="160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Axis x: C= negative control (1,2, </a:t>
            </a:r>
            <a:r>
              <a:rPr lang="en-GB" sz="1600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depending on the confocal session), plus the location of the tissues retrieved with the specific signal. Colours refer to the negative control and the tissues: violet= negative control, black= </a:t>
            </a:r>
            <a:r>
              <a:rPr lang="en-GB" sz="1600" dirty="0" err="1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branchiae</a:t>
            </a:r>
            <a:r>
              <a:rPr lang="en-GB" sz="1600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, light blue= inner epithelium (digestive), yellow= integument, orange= muscles, green= organs. Axis y representing the intensity of the fluorescence converted in </a:t>
            </a:r>
            <a:r>
              <a:rPr lang="en-GB" sz="1600" dirty="0" err="1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gray</a:t>
            </a:r>
            <a:r>
              <a:rPr lang="en-GB" sz="1600" dirty="0">
                <a:solidFill>
                  <a:srgbClr val="000000"/>
                </a:solidFill>
                <a:effectLst/>
                <a:latin typeface="Times New Roman"/>
                <a:ea typeface="Calibri"/>
                <a:cs typeface="Times New Roman"/>
              </a:rPr>
              <a:t> value in each pixel².</a:t>
            </a:r>
            <a:r>
              <a:rPr lang="en-GB" sz="16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 </a:t>
            </a:r>
            <a:endParaRPr lang="en-GB" sz="1600" dirty="0">
              <a:ea typeface="Calibri"/>
              <a:cs typeface="Calibri"/>
            </a:endParaRPr>
          </a:p>
        </p:txBody>
      </p:sp>
      <p:pic>
        <p:nvPicPr>
          <p:cNvPr id="2" name="Obraz 1" descr="Obraz zawierający zrzut ekranu&#10;&#10;Opis wygenerowany automatycznie">
            <a:extLst>
              <a:ext uri="{FF2B5EF4-FFF2-40B4-BE49-F238E27FC236}">
                <a16:creationId xmlns:a16="http://schemas.microsoft.com/office/drawing/2014/main" id="{A5C6CDD2-B2F4-6FB4-4BE2-28F602BF89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4121" y="1831349"/>
            <a:ext cx="8675783" cy="4818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347590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Application>Microsoft Office PowerPoint</Application>
  <PresentationFormat>Panoramiczny</PresentationFormat>
  <Slides>7</Slides>
  <Notes>1</Notes>
  <HiddenSlides>0</HiddenSlide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7</vt:i4>
      </vt:variant>
    </vt:vector>
  </HeadingPairs>
  <TitlesOfParts>
    <vt:vector size="8" baseType="lpstr">
      <vt:lpstr>Tema do Office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Serena Mucciolo</dc:creator>
  <cp:revision>27</cp:revision>
  <dcterms:created xsi:type="dcterms:W3CDTF">2022-09-07T09:08:20Z</dcterms:created>
  <dcterms:modified xsi:type="dcterms:W3CDTF">2024-03-27T09:04:56Z</dcterms:modified>
</cp:coreProperties>
</file>